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4">
          <p15:clr>
            <a:srgbClr val="A4A3A4"/>
          </p15:clr>
        </p15:guide>
        <p15:guide id="2" pos="258">
          <p15:clr>
            <a:srgbClr val="A4A3A4"/>
          </p15:clr>
        </p15:guide>
        <p15:guide id="3" orient="horz" pos="382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400" y="62"/>
      </p:cViewPr>
      <p:guideLst>
        <p:guide orient="horz" pos="4864"/>
        <p:guide pos="258"/>
        <p:guide orient="horz" pos="382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unka\MBK\Zula\Tuber%20graph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unka\MBK\Zula\Tuber%20graph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 sz="1800" b="1"/>
              <a:t>WL</a:t>
            </a:r>
            <a:r>
              <a:rPr lang="hu-HU" sz="1800" b="1" baseline="0"/>
              <a:t> tuber</a:t>
            </a:r>
            <a:endParaRPr lang="hu-HU" sz="1800" b="1"/>
          </a:p>
        </c:rich>
      </c:tx>
      <c:layout>
        <c:manualLayout>
          <c:xMode val="edge"/>
          <c:yMode val="edge"/>
          <c:x val="0.43239349192279214"/>
          <c:y val="3.8103021569610477E-3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2!$Q$2:$Q$31</c:f>
                <c:numCache>
                  <c:formatCode>General</c:formatCode>
                  <c:ptCount val="30"/>
                  <c:pt idx="0">
                    <c:v>1.7857104922192948</c:v>
                  </c:pt>
                  <c:pt idx="1">
                    <c:v>0.79561972588881225</c:v>
                  </c:pt>
                  <c:pt idx="2">
                    <c:v>1.0759894564994712</c:v>
                  </c:pt>
                  <c:pt idx="3">
                    <c:v>0.10652573331394322</c:v>
                  </c:pt>
                  <c:pt idx="4">
                    <c:v>1.5558457273273538</c:v>
                  </c:pt>
                  <c:pt idx="5">
                    <c:v>0.30826864407292282</c:v>
                  </c:pt>
                  <c:pt idx="6">
                    <c:v>5.5473652428061383E-2</c:v>
                  </c:pt>
                  <c:pt idx="7">
                    <c:v>1.0511134429706197</c:v>
                  </c:pt>
                  <c:pt idx="8">
                    <c:v>2.9877327295682732</c:v>
                  </c:pt>
                  <c:pt idx="9">
                    <c:v>0.33952927219075679</c:v>
                  </c:pt>
                  <c:pt idx="10">
                    <c:v>0.67006348992815079</c:v>
                  </c:pt>
                  <c:pt idx="11">
                    <c:v>0.44349735667203855</c:v>
                  </c:pt>
                  <c:pt idx="12">
                    <c:v>0.51918698748244807</c:v>
                  </c:pt>
                  <c:pt idx="13">
                    <c:v>4.5214869873505057</c:v>
                  </c:pt>
                  <c:pt idx="14">
                    <c:v>1.4747714150922338</c:v>
                  </c:pt>
                  <c:pt idx="15">
                    <c:v>8.5812599287774696E-2</c:v>
                  </c:pt>
                  <c:pt idx="16">
                    <c:v>2.7085825011524878</c:v>
                  </c:pt>
                  <c:pt idx="17">
                    <c:v>55.486122119090645</c:v>
                  </c:pt>
                  <c:pt idx="18">
                    <c:v>0.13303473234798241</c:v>
                  </c:pt>
                  <c:pt idx="19">
                    <c:v>0.25577511576933726</c:v>
                  </c:pt>
                  <c:pt idx="20">
                    <c:v>6.7860455709611883E-2</c:v>
                  </c:pt>
                  <c:pt idx="21">
                    <c:v>2.3899256503895234</c:v>
                  </c:pt>
                  <c:pt idx="22">
                    <c:v>2.8793172492994606E-2</c:v>
                  </c:pt>
                  <c:pt idx="23">
                    <c:v>11.41622021954951</c:v>
                  </c:pt>
                  <c:pt idx="24">
                    <c:v>2.5644865911445412E-2</c:v>
                  </c:pt>
                  <c:pt idx="25">
                    <c:v>9.6417866006883214E-3</c:v>
                  </c:pt>
                  <c:pt idx="26">
                    <c:v>4.0331201857604977E-2</c:v>
                  </c:pt>
                  <c:pt idx="27">
                    <c:v>3.9631471649771696E-2</c:v>
                  </c:pt>
                  <c:pt idx="28">
                    <c:v>4.3257049836288301E-2</c:v>
                  </c:pt>
                  <c:pt idx="29">
                    <c:v>6.33355395648370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2!$B$2:$B$31</c:f>
              <c:strCache>
                <c:ptCount val="30"/>
                <c:pt idx="0">
                  <c:v>Valine </c:v>
                </c:pt>
                <c:pt idx="1">
                  <c:v>Isoleucine</c:v>
                </c:pt>
                <c:pt idx="2">
                  <c:v>Proline</c:v>
                </c:pt>
                <c:pt idx="3">
                  <c:v>Glycine</c:v>
                </c:pt>
                <c:pt idx="4">
                  <c:v>Serine </c:v>
                </c:pt>
                <c:pt idx="5">
                  <c:v>L-Threonine</c:v>
                </c:pt>
                <c:pt idx="6">
                  <c:v>B-alanine</c:v>
                </c:pt>
                <c:pt idx="7">
                  <c:v>L-Aspartic-acid</c:v>
                </c:pt>
                <c:pt idx="8">
                  <c:v>5-oxo-Proline</c:v>
                </c:pt>
                <c:pt idx="9">
                  <c:v>GABA</c:v>
                </c:pt>
                <c:pt idx="10">
                  <c:v>Ornithine</c:v>
                </c:pt>
                <c:pt idx="11">
                  <c:v>Glutamic acid</c:v>
                </c:pt>
                <c:pt idx="12">
                  <c:v>Phenylalanine</c:v>
                </c:pt>
                <c:pt idx="13">
                  <c:v>L-Asparagine</c:v>
                </c:pt>
                <c:pt idx="14">
                  <c:v>Fructose</c:v>
                </c:pt>
                <c:pt idx="15">
                  <c:v>Galactose</c:v>
                </c:pt>
                <c:pt idx="16">
                  <c:v>Glucose</c:v>
                </c:pt>
                <c:pt idx="17">
                  <c:v>Sucrose</c:v>
                </c:pt>
                <c:pt idx="18">
                  <c:v>Mannitol</c:v>
                </c:pt>
                <c:pt idx="19">
                  <c:v>Myo-inositol</c:v>
                </c:pt>
                <c:pt idx="20">
                  <c:v>Galactinol </c:v>
                </c:pt>
                <c:pt idx="21">
                  <c:v>Malic acid</c:v>
                </c:pt>
                <c:pt idx="22">
                  <c:v>Pentonic acid</c:v>
                </c:pt>
                <c:pt idx="23">
                  <c:v>Citric acid</c:v>
                </c:pt>
                <c:pt idx="24">
                  <c:v>Palmitic acid</c:v>
                </c:pt>
                <c:pt idx="25">
                  <c:v>Galactaric acid</c:v>
                </c:pt>
                <c:pt idx="26">
                  <c:v> Lactulose</c:v>
                </c:pt>
                <c:pt idx="27">
                  <c:v>Stearic acid</c:v>
                </c:pt>
                <c:pt idx="28">
                  <c:v>Galacturonic acid</c:v>
                </c:pt>
                <c:pt idx="29">
                  <c:v>Phosphoric acid</c:v>
                </c:pt>
              </c:strCache>
            </c:strRef>
          </c:cat>
          <c:val>
            <c:numRef>
              <c:f>Munka2!$P$2:$P$31</c:f>
              <c:numCache>
                <c:formatCode>General</c:formatCode>
                <c:ptCount val="30"/>
                <c:pt idx="0">
                  <c:v>5.8954986324750145</c:v>
                </c:pt>
                <c:pt idx="1">
                  <c:v>2.0048707589730039</c:v>
                </c:pt>
                <c:pt idx="2">
                  <c:v>1.5753426031901228</c:v>
                </c:pt>
                <c:pt idx="3">
                  <c:v>0.6114665129285527</c:v>
                </c:pt>
                <c:pt idx="4">
                  <c:v>4.1876413044635319</c:v>
                </c:pt>
                <c:pt idx="5">
                  <c:v>1.7744592523043803</c:v>
                </c:pt>
                <c:pt idx="6">
                  <c:v>0.21088047701932941</c:v>
                </c:pt>
                <c:pt idx="7">
                  <c:v>6.3837932861839404</c:v>
                </c:pt>
                <c:pt idx="8">
                  <c:v>8.461111994840099</c:v>
                </c:pt>
                <c:pt idx="9">
                  <c:v>2.2363661483010802</c:v>
                </c:pt>
                <c:pt idx="10">
                  <c:v>1.0405181294194081</c:v>
                </c:pt>
                <c:pt idx="11">
                  <c:v>4.7899311180985213</c:v>
                </c:pt>
                <c:pt idx="12">
                  <c:v>1.0706293351702778</c:v>
                </c:pt>
                <c:pt idx="13">
                  <c:v>18.959058492834107</c:v>
                </c:pt>
                <c:pt idx="14">
                  <c:v>2.843997747675802</c:v>
                </c:pt>
                <c:pt idx="15">
                  <c:v>0.16764567480000001</c:v>
                </c:pt>
                <c:pt idx="16">
                  <c:v>5.5381107756157757</c:v>
                </c:pt>
                <c:pt idx="17">
                  <c:v>94.816843067024848</c:v>
                </c:pt>
                <c:pt idx="18">
                  <c:v>0.46465374809660026</c:v>
                </c:pt>
                <c:pt idx="19">
                  <c:v>1.7992826733344238</c:v>
                </c:pt>
                <c:pt idx="20">
                  <c:v>0.14196356823118297</c:v>
                </c:pt>
                <c:pt idx="21">
                  <c:v>8.6136353656267008</c:v>
                </c:pt>
                <c:pt idx="22">
                  <c:v>0.14019468499123741</c:v>
                </c:pt>
                <c:pt idx="23">
                  <c:v>46.998663700929946</c:v>
                </c:pt>
                <c:pt idx="24">
                  <c:v>0.19244658645695228</c:v>
                </c:pt>
                <c:pt idx="25">
                  <c:v>5.8485508820882506E-2</c:v>
                </c:pt>
                <c:pt idx="26">
                  <c:v>0.1669565344295329</c:v>
                </c:pt>
                <c:pt idx="27">
                  <c:v>0.19249718537354141</c:v>
                </c:pt>
                <c:pt idx="28">
                  <c:v>5.7029211105821202E-2</c:v>
                </c:pt>
                <c:pt idx="29">
                  <c:v>16.1267203850404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84-4B85-87E3-46936F3675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83866688"/>
        <c:axId val="883857984"/>
      </c:barChart>
      <c:catAx>
        <c:axId val="883866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3857984"/>
        <c:crosses val="autoZero"/>
        <c:auto val="1"/>
        <c:lblAlgn val="ctr"/>
        <c:lblOffset val="100"/>
        <c:noMultiLvlLbl val="0"/>
      </c:catAx>
      <c:valAx>
        <c:axId val="883857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/>
                  <a:t>Relative</a:t>
                </a:r>
                <a:r>
                  <a:rPr lang="hu-HU" baseline="0"/>
                  <a:t> content</a:t>
                </a:r>
                <a:endParaRPr lang="hu-HU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3866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 sz="1800" b="1"/>
              <a:t>HP</a:t>
            </a:r>
            <a:r>
              <a:rPr lang="hu-HU" sz="1800" b="1" baseline="0"/>
              <a:t> tuber</a:t>
            </a:r>
            <a:endParaRPr lang="hu-HU" sz="1800" b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2!$I$2:$I$31</c:f>
                <c:numCache>
                  <c:formatCode>General</c:formatCode>
                  <c:ptCount val="30"/>
                  <c:pt idx="0">
                    <c:v>0.5492492014745165</c:v>
                  </c:pt>
                  <c:pt idx="1">
                    <c:v>0.32415769001474437</c:v>
                  </c:pt>
                  <c:pt idx="2">
                    <c:v>0.48909797177944259</c:v>
                  </c:pt>
                  <c:pt idx="3">
                    <c:v>0.12425790901443833</c:v>
                  </c:pt>
                  <c:pt idx="4">
                    <c:v>1.3260346884309298</c:v>
                  </c:pt>
                  <c:pt idx="5">
                    <c:v>0.41162464781600239</c:v>
                  </c:pt>
                  <c:pt idx="6">
                    <c:v>7.6688231344350363E-2</c:v>
                  </c:pt>
                  <c:pt idx="7">
                    <c:v>1.1956132260435861</c:v>
                  </c:pt>
                  <c:pt idx="8">
                    <c:v>4.1698583641678271</c:v>
                  </c:pt>
                  <c:pt idx="9">
                    <c:v>1.1321199855994488</c:v>
                  </c:pt>
                  <c:pt idx="10">
                    <c:v>0.31270623634617895</c:v>
                  </c:pt>
                  <c:pt idx="11">
                    <c:v>1.631504884978576</c:v>
                  </c:pt>
                  <c:pt idx="12">
                    <c:v>0.19981732712373676</c:v>
                  </c:pt>
                  <c:pt idx="13">
                    <c:v>3.7648842027383846</c:v>
                  </c:pt>
                  <c:pt idx="14">
                    <c:v>0.72754602379697242</c:v>
                  </c:pt>
                  <c:pt idx="15">
                    <c:v>0.10888976567836535</c:v>
                  </c:pt>
                  <c:pt idx="16">
                    <c:v>2.9227812874590682</c:v>
                  </c:pt>
                  <c:pt idx="17">
                    <c:v>59.248910827498946</c:v>
                  </c:pt>
                  <c:pt idx="18">
                    <c:v>9.0391387722060845E-2</c:v>
                  </c:pt>
                  <c:pt idx="19">
                    <c:v>0.29854223027407262</c:v>
                  </c:pt>
                  <c:pt idx="20">
                    <c:v>6.5354824583513729E-2</c:v>
                  </c:pt>
                  <c:pt idx="21">
                    <c:v>3.5831863560522352</c:v>
                  </c:pt>
                  <c:pt idx="22">
                    <c:v>0.15743791075076968</c:v>
                  </c:pt>
                  <c:pt idx="23">
                    <c:v>12.234462982021348</c:v>
                  </c:pt>
                  <c:pt idx="24">
                    <c:v>8.1317249947742948E-2</c:v>
                  </c:pt>
                  <c:pt idx="25">
                    <c:v>3.1698932995412356E-2</c:v>
                  </c:pt>
                  <c:pt idx="26">
                    <c:v>0.10664430017988659</c:v>
                  </c:pt>
                  <c:pt idx="27">
                    <c:v>0.20070566858072644</c:v>
                  </c:pt>
                  <c:pt idx="28">
                    <c:v>3.3368522496527608E-2</c:v>
                  </c:pt>
                  <c:pt idx="29">
                    <c:v>6.82504261919007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2!$B$2:$B$31</c:f>
              <c:strCache>
                <c:ptCount val="30"/>
                <c:pt idx="0">
                  <c:v>Valine </c:v>
                </c:pt>
                <c:pt idx="1">
                  <c:v>Isoleucine</c:v>
                </c:pt>
                <c:pt idx="2">
                  <c:v>Proline</c:v>
                </c:pt>
                <c:pt idx="3">
                  <c:v>Glycine</c:v>
                </c:pt>
                <c:pt idx="4">
                  <c:v>Serine </c:v>
                </c:pt>
                <c:pt idx="5">
                  <c:v>L-Threonine</c:v>
                </c:pt>
                <c:pt idx="6">
                  <c:v>B-alanine</c:v>
                </c:pt>
                <c:pt idx="7">
                  <c:v>L-Aspartic-acid</c:v>
                </c:pt>
                <c:pt idx="8">
                  <c:v>5-oxo-Proline</c:v>
                </c:pt>
                <c:pt idx="9">
                  <c:v>GABA</c:v>
                </c:pt>
                <c:pt idx="10">
                  <c:v>Ornithine</c:v>
                </c:pt>
                <c:pt idx="11">
                  <c:v>Glutamic acid</c:v>
                </c:pt>
                <c:pt idx="12">
                  <c:v>Phenylalanine</c:v>
                </c:pt>
                <c:pt idx="13">
                  <c:v>L-Asparagine</c:v>
                </c:pt>
                <c:pt idx="14">
                  <c:v>Fructose</c:v>
                </c:pt>
                <c:pt idx="15">
                  <c:v>Galactose</c:v>
                </c:pt>
                <c:pt idx="16">
                  <c:v>Glucose</c:v>
                </c:pt>
                <c:pt idx="17">
                  <c:v>Sucrose</c:v>
                </c:pt>
                <c:pt idx="18">
                  <c:v>Mannitol</c:v>
                </c:pt>
                <c:pt idx="19">
                  <c:v>Myo-inositol</c:v>
                </c:pt>
                <c:pt idx="20">
                  <c:v>Galactinol </c:v>
                </c:pt>
                <c:pt idx="21">
                  <c:v>Malic acid</c:v>
                </c:pt>
                <c:pt idx="22">
                  <c:v>Pentonic acid</c:v>
                </c:pt>
                <c:pt idx="23">
                  <c:v>Citric acid</c:v>
                </c:pt>
                <c:pt idx="24">
                  <c:v>Palmitic acid</c:v>
                </c:pt>
                <c:pt idx="25">
                  <c:v>Galactaric acid</c:v>
                </c:pt>
                <c:pt idx="26">
                  <c:v> Lactulose</c:v>
                </c:pt>
                <c:pt idx="27">
                  <c:v>Stearic acid</c:v>
                </c:pt>
                <c:pt idx="28">
                  <c:v>Galacturonic acid</c:v>
                </c:pt>
                <c:pt idx="29">
                  <c:v>Phosphoric acid</c:v>
                </c:pt>
              </c:strCache>
            </c:strRef>
          </c:cat>
          <c:val>
            <c:numRef>
              <c:f>Munka2!$H$2:$H$31</c:f>
              <c:numCache>
                <c:formatCode>General</c:formatCode>
                <c:ptCount val="30"/>
                <c:pt idx="0">
                  <c:v>2.613055607502706</c:v>
                </c:pt>
                <c:pt idx="1">
                  <c:v>0.90151939239750178</c:v>
                </c:pt>
                <c:pt idx="2">
                  <c:v>3.4476160181009741</c:v>
                </c:pt>
                <c:pt idx="3">
                  <c:v>0.58351370582095996</c:v>
                </c:pt>
                <c:pt idx="4">
                  <c:v>2.3655934447242548</c:v>
                </c:pt>
                <c:pt idx="5">
                  <c:v>1.1469943174495802</c:v>
                </c:pt>
                <c:pt idx="6">
                  <c:v>0.2525857485494748</c:v>
                </c:pt>
                <c:pt idx="7">
                  <c:v>4.3666968677819318</c:v>
                </c:pt>
                <c:pt idx="8">
                  <c:v>11.099917985375667</c:v>
                </c:pt>
                <c:pt idx="9">
                  <c:v>2.5329610661661688</c:v>
                </c:pt>
                <c:pt idx="10">
                  <c:v>0.31832419437379311</c:v>
                </c:pt>
                <c:pt idx="11">
                  <c:v>3.8814585119758056</c:v>
                </c:pt>
                <c:pt idx="12">
                  <c:v>0.31675790536199128</c:v>
                </c:pt>
                <c:pt idx="13">
                  <c:v>11.510883055224674</c:v>
                </c:pt>
                <c:pt idx="14">
                  <c:v>1.6547790007964593</c:v>
                </c:pt>
                <c:pt idx="15">
                  <c:v>0.20270612800000004</c:v>
                </c:pt>
                <c:pt idx="16">
                  <c:v>3.5950281295876167</c:v>
                </c:pt>
                <c:pt idx="17">
                  <c:v>255.53788203127388</c:v>
                </c:pt>
                <c:pt idx="18">
                  <c:v>0.52582353225533973</c:v>
                </c:pt>
                <c:pt idx="19">
                  <c:v>1.892137225692448</c:v>
                </c:pt>
                <c:pt idx="20">
                  <c:v>0.21957435441812045</c:v>
                </c:pt>
                <c:pt idx="21">
                  <c:v>8.7782117774009585</c:v>
                </c:pt>
                <c:pt idx="22">
                  <c:v>0.31291337652607831</c:v>
                </c:pt>
                <c:pt idx="23">
                  <c:v>63.109223258513424</c:v>
                </c:pt>
                <c:pt idx="24">
                  <c:v>0.33725714458191525</c:v>
                </c:pt>
                <c:pt idx="25">
                  <c:v>8.9241869729954723E-2</c:v>
                </c:pt>
                <c:pt idx="26">
                  <c:v>0.35043456321914296</c:v>
                </c:pt>
                <c:pt idx="27">
                  <c:v>0.42953596847839243</c:v>
                </c:pt>
                <c:pt idx="28">
                  <c:v>0.11471699727355562</c:v>
                </c:pt>
                <c:pt idx="29">
                  <c:v>17.6119779255416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33-4B69-9CB9-84222E5538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83860160"/>
        <c:axId val="883869952"/>
      </c:barChart>
      <c:catAx>
        <c:axId val="883860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3869952"/>
        <c:crosses val="autoZero"/>
        <c:auto val="1"/>
        <c:lblAlgn val="ctr"/>
        <c:lblOffset val="100"/>
        <c:noMultiLvlLbl val="0"/>
      </c:catAx>
      <c:valAx>
        <c:axId val="8838699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/>
                  <a:t>Relative</a:t>
                </a:r>
                <a:r>
                  <a:rPr lang="hu-HU" baseline="0"/>
                  <a:t> content</a:t>
                </a:r>
                <a:endParaRPr lang="hu-HU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3860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D56CE7-45B3-4FAB-A35A-4A8B159AF181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125FFE-C387-45C8-871E-69CC90045C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11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28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44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91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160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40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7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607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80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375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7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27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7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Diagram 53"/>
          <p:cNvGraphicFramePr>
            <a:graphicFrameLocks/>
          </p:cNvGraphicFramePr>
          <p:nvPr/>
        </p:nvGraphicFramePr>
        <p:xfrm>
          <a:off x="0" y="4267199"/>
          <a:ext cx="6858001" cy="33330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3" name="Csoportba foglalás 2"/>
          <p:cNvGrpSpPr/>
          <p:nvPr/>
        </p:nvGrpSpPr>
        <p:grpSpPr>
          <a:xfrm>
            <a:off x="413581" y="3605797"/>
            <a:ext cx="6287640" cy="412461"/>
            <a:chOff x="400050" y="3800801"/>
            <a:chExt cx="6287640" cy="412461"/>
          </a:xfrm>
        </p:grpSpPr>
        <p:grpSp>
          <p:nvGrpSpPr>
            <p:cNvPr id="4" name="Csoportba foglalás 3"/>
            <p:cNvGrpSpPr/>
            <p:nvPr/>
          </p:nvGrpSpPr>
          <p:grpSpPr>
            <a:xfrm>
              <a:off x="400050" y="3803563"/>
              <a:ext cx="2844800" cy="146137"/>
              <a:chOff x="400050" y="3682913"/>
              <a:chExt cx="2844800" cy="146137"/>
            </a:xfrm>
          </p:grpSpPr>
          <p:cxnSp>
            <p:nvCxnSpPr>
              <p:cNvPr id="22" name="Egyenes összekötő 21"/>
              <p:cNvCxnSpPr/>
              <p:nvPr/>
            </p:nvCxnSpPr>
            <p:spPr>
              <a:xfrm>
                <a:off x="406400" y="3682913"/>
                <a:ext cx="0" cy="1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Egyenes összekötő 22"/>
              <p:cNvCxnSpPr/>
              <p:nvPr/>
            </p:nvCxnSpPr>
            <p:spPr>
              <a:xfrm>
                <a:off x="400050" y="3829050"/>
                <a:ext cx="284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Egyenes összekötő 23"/>
              <p:cNvCxnSpPr/>
              <p:nvPr/>
            </p:nvCxnSpPr>
            <p:spPr>
              <a:xfrm>
                <a:off x="3244850" y="3682913"/>
                <a:ext cx="0" cy="1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" name="Egyenes összekötő 4"/>
            <p:cNvCxnSpPr/>
            <p:nvPr/>
          </p:nvCxnSpPr>
          <p:spPr>
            <a:xfrm>
              <a:off x="3309719" y="3802388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Egyenes összekötő 5"/>
            <p:cNvCxnSpPr/>
            <p:nvPr/>
          </p:nvCxnSpPr>
          <p:spPr>
            <a:xfrm>
              <a:off x="3308089" y="3949708"/>
              <a:ext cx="75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Egyenes összekötő 6"/>
            <p:cNvCxnSpPr/>
            <p:nvPr/>
          </p:nvCxnSpPr>
          <p:spPr>
            <a:xfrm>
              <a:off x="4057041" y="3802388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Egyenes összekötő 7"/>
            <p:cNvCxnSpPr/>
            <p:nvPr/>
          </p:nvCxnSpPr>
          <p:spPr>
            <a:xfrm>
              <a:off x="4109471" y="3800801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Egyenes összekötő 8"/>
            <p:cNvCxnSpPr/>
            <p:nvPr/>
          </p:nvCxnSpPr>
          <p:spPr>
            <a:xfrm>
              <a:off x="4103208" y="3949564"/>
              <a:ext cx="50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Egyenes összekötő 9"/>
            <p:cNvCxnSpPr/>
            <p:nvPr/>
          </p:nvCxnSpPr>
          <p:spPr>
            <a:xfrm>
              <a:off x="4602619" y="3800801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Egyenes összekötő 10"/>
            <p:cNvCxnSpPr/>
            <p:nvPr/>
          </p:nvCxnSpPr>
          <p:spPr>
            <a:xfrm>
              <a:off x="4662703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Egyenes összekötő 11"/>
            <p:cNvCxnSpPr/>
            <p:nvPr/>
          </p:nvCxnSpPr>
          <p:spPr>
            <a:xfrm>
              <a:off x="4662703" y="3949564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Egyenes összekötő 12"/>
            <p:cNvCxnSpPr/>
            <p:nvPr/>
          </p:nvCxnSpPr>
          <p:spPr>
            <a:xfrm>
              <a:off x="5997810" y="3805564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Egyenes összekötő 13"/>
            <p:cNvCxnSpPr/>
            <p:nvPr/>
          </p:nvCxnSpPr>
          <p:spPr>
            <a:xfrm>
              <a:off x="6065615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Egyenes összekötő 14"/>
            <p:cNvCxnSpPr/>
            <p:nvPr/>
          </p:nvCxnSpPr>
          <p:spPr>
            <a:xfrm>
              <a:off x="6065615" y="3951652"/>
              <a:ext cx="5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Egyenes összekötő 15"/>
            <p:cNvCxnSpPr/>
            <p:nvPr/>
          </p:nvCxnSpPr>
          <p:spPr>
            <a:xfrm>
              <a:off x="6602604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Szövegdoboz 16"/>
            <p:cNvSpPr txBox="1"/>
            <p:nvPr/>
          </p:nvSpPr>
          <p:spPr>
            <a:xfrm>
              <a:off x="1246340" y="3951652"/>
              <a:ext cx="8771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Amino</a:t>
              </a:r>
              <a:r>
                <a:rPr lang="hu-HU" sz="1100"/>
                <a:t> </a:t>
              </a:r>
              <a:r>
                <a:rPr lang="hu-HU" sz="1100" err="1"/>
                <a:t>acids</a:t>
              </a:r>
              <a:endParaRPr lang="hu-HU" sz="1100"/>
            </a:p>
          </p:txBody>
        </p:sp>
        <p:sp>
          <p:nvSpPr>
            <p:cNvPr id="18" name="Szövegdoboz 17"/>
            <p:cNvSpPr txBox="1"/>
            <p:nvPr/>
          </p:nvSpPr>
          <p:spPr>
            <a:xfrm>
              <a:off x="3374989" y="3939546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Sugars</a:t>
              </a:r>
              <a:endParaRPr lang="hu-HU" sz="1100"/>
            </a:p>
          </p:txBody>
        </p:sp>
        <p:sp>
          <p:nvSpPr>
            <p:cNvPr id="19" name="Szövegdoboz 18"/>
            <p:cNvSpPr txBox="1"/>
            <p:nvPr/>
          </p:nvSpPr>
          <p:spPr>
            <a:xfrm>
              <a:off x="4014557" y="3939546"/>
              <a:ext cx="7312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Sugar</a:t>
              </a:r>
              <a:r>
                <a:rPr lang="hu-HU" sz="1100"/>
                <a:t> </a:t>
              </a:r>
              <a:r>
                <a:rPr lang="hu-HU" sz="1100" err="1"/>
                <a:t>alc</a:t>
              </a:r>
              <a:r>
                <a:rPr lang="hu-HU" sz="1100"/>
                <a:t>.</a:t>
              </a:r>
            </a:p>
          </p:txBody>
        </p:sp>
        <p:sp>
          <p:nvSpPr>
            <p:cNvPr id="20" name="Szövegdoboz 19"/>
            <p:cNvSpPr txBox="1"/>
            <p:nvPr/>
          </p:nvSpPr>
          <p:spPr>
            <a:xfrm>
              <a:off x="4840043" y="3939546"/>
              <a:ext cx="9797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Organic</a:t>
              </a:r>
              <a:r>
                <a:rPr lang="hu-HU" sz="1100"/>
                <a:t> </a:t>
              </a:r>
              <a:r>
                <a:rPr lang="hu-HU" sz="1100" err="1"/>
                <a:t>acids</a:t>
              </a:r>
              <a:endParaRPr lang="hu-HU" sz="1100"/>
            </a:p>
          </p:txBody>
        </p:sp>
        <p:sp>
          <p:nvSpPr>
            <p:cNvPr id="21" name="Szövegdoboz 20"/>
            <p:cNvSpPr txBox="1"/>
            <p:nvPr/>
          </p:nvSpPr>
          <p:spPr>
            <a:xfrm>
              <a:off x="5975636" y="3930899"/>
              <a:ext cx="7120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Inorg</a:t>
              </a:r>
              <a:r>
                <a:rPr lang="hu-HU" sz="1100"/>
                <a:t>. </a:t>
              </a:r>
              <a:r>
                <a:rPr lang="hu-HU" sz="1100" err="1"/>
                <a:t>ac</a:t>
              </a:r>
              <a:r>
                <a:rPr lang="hu-HU" sz="1100"/>
                <a:t>.</a:t>
              </a:r>
            </a:p>
          </p:txBody>
        </p:sp>
      </p:grpSp>
      <p:grpSp>
        <p:nvGrpSpPr>
          <p:cNvPr id="26" name="Csoportba foglalás 25"/>
          <p:cNvGrpSpPr/>
          <p:nvPr/>
        </p:nvGrpSpPr>
        <p:grpSpPr>
          <a:xfrm>
            <a:off x="413576" y="7568196"/>
            <a:ext cx="6287640" cy="412461"/>
            <a:chOff x="400050" y="3800801"/>
            <a:chExt cx="6287640" cy="412461"/>
          </a:xfrm>
        </p:grpSpPr>
        <p:grpSp>
          <p:nvGrpSpPr>
            <p:cNvPr id="27" name="Csoportba foglalás 26"/>
            <p:cNvGrpSpPr/>
            <p:nvPr/>
          </p:nvGrpSpPr>
          <p:grpSpPr>
            <a:xfrm>
              <a:off x="400050" y="3803563"/>
              <a:ext cx="2844800" cy="146137"/>
              <a:chOff x="400050" y="3682913"/>
              <a:chExt cx="2844800" cy="146137"/>
            </a:xfrm>
          </p:grpSpPr>
          <p:cxnSp>
            <p:nvCxnSpPr>
              <p:cNvPr id="45" name="Egyenes összekötő 44"/>
              <p:cNvCxnSpPr/>
              <p:nvPr/>
            </p:nvCxnSpPr>
            <p:spPr>
              <a:xfrm>
                <a:off x="406400" y="3682913"/>
                <a:ext cx="0" cy="1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Egyenes összekötő 45"/>
              <p:cNvCxnSpPr/>
              <p:nvPr/>
            </p:nvCxnSpPr>
            <p:spPr>
              <a:xfrm>
                <a:off x="400050" y="3829050"/>
                <a:ext cx="284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Egyenes összekötő 46"/>
              <p:cNvCxnSpPr/>
              <p:nvPr/>
            </p:nvCxnSpPr>
            <p:spPr>
              <a:xfrm>
                <a:off x="3244850" y="3682913"/>
                <a:ext cx="0" cy="1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" name="Egyenes összekötő 27"/>
            <p:cNvCxnSpPr/>
            <p:nvPr/>
          </p:nvCxnSpPr>
          <p:spPr>
            <a:xfrm>
              <a:off x="3309719" y="3802388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Egyenes összekötő 28"/>
            <p:cNvCxnSpPr/>
            <p:nvPr/>
          </p:nvCxnSpPr>
          <p:spPr>
            <a:xfrm>
              <a:off x="3308089" y="3949708"/>
              <a:ext cx="75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Egyenes összekötő 29"/>
            <p:cNvCxnSpPr/>
            <p:nvPr/>
          </p:nvCxnSpPr>
          <p:spPr>
            <a:xfrm>
              <a:off x="4057041" y="3802388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Egyenes összekötő 30"/>
            <p:cNvCxnSpPr/>
            <p:nvPr/>
          </p:nvCxnSpPr>
          <p:spPr>
            <a:xfrm>
              <a:off x="4109471" y="3800801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Egyenes összekötő 31"/>
            <p:cNvCxnSpPr/>
            <p:nvPr/>
          </p:nvCxnSpPr>
          <p:spPr>
            <a:xfrm>
              <a:off x="4103208" y="3949564"/>
              <a:ext cx="50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Egyenes összekötő 32"/>
            <p:cNvCxnSpPr/>
            <p:nvPr/>
          </p:nvCxnSpPr>
          <p:spPr>
            <a:xfrm>
              <a:off x="4602619" y="3800801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Egyenes összekötő 33"/>
            <p:cNvCxnSpPr/>
            <p:nvPr/>
          </p:nvCxnSpPr>
          <p:spPr>
            <a:xfrm>
              <a:off x="4662703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Egyenes összekötő 34"/>
            <p:cNvCxnSpPr/>
            <p:nvPr/>
          </p:nvCxnSpPr>
          <p:spPr>
            <a:xfrm>
              <a:off x="4662703" y="3949564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Egyenes összekötő 35"/>
            <p:cNvCxnSpPr/>
            <p:nvPr/>
          </p:nvCxnSpPr>
          <p:spPr>
            <a:xfrm>
              <a:off x="5997810" y="3805564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Egyenes összekötő 36"/>
            <p:cNvCxnSpPr/>
            <p:nvPr/>
          </p:nvCxnSpPr>
          <p:spPr>
            <a:xfrm>
              <a:off x="6065615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Egyenes összekötő 37"/>
            <p:cNvCxnSpPr/>
            <p:nvPr/>
          </p:nvCxnSpPr>
          <p:spPr>
            <a:xfrm>
              <a:off x="6065615" y="3951652"/>
              <a:ext cx="5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Egyenes összekötő 38"/>
            <p:cNvCxnSpPr/>
            <p:nvPr/>
          </p:nvCxnSpPr>
          <p:spPr>
            <a:xfrm>
              <a:off x="6602604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Szövegdoboz 39"/>
            <p:cNvSpPr txBox="1"/>
            <p:nvPr/>
          </p:nvSpPr>
          <p:spPr>
            <a:xfrm>
              <a:off x="1246340" y="3951652"/>
              <a:ext cx="8771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Amino</a:t>
              </a:r>
              <a:r>
                <a:rPr lang="hu-HU" sz="1100"/>
                <a:t> </a:t>
              </a:r>
              <a:r>
                <a:rPr lang="hu-HU" sz="1100" err="1"/>
                <a:t>acids</a:t>
              </a:r>
              <a:endParaRPr lang="hu-HU" sz="1100"/>
            </a:p>
          </p:txBody>
        </p:sp>
        <p:sp>
          <p:nvSpPr>
            <p:cNvPr id="41" name="Szövegdoboz 40"/>
            <p:cNvSpPr txBox="1"/>
            <p:nvPr/>
          </p:nvSpPr>
          <p:spPr>
            <a:xfrm>
              <a:off x="3374989" y="3939546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Sugars</a:t>
              </a:r>
              <a:endParaRPr lang="hu-HU" sz="1100"/>
            </a:p>
          </p:txBody>
        </p:sp>
        <p:sp>
          <p:nvSpPr>
            <p:cNvPr id="42" name="Szövegdoboz 41"/>
            <p:cNvSpPr txBox="1"/>
            <p:nvPr/>
          </p:nvSpPr>
          <p:spPr>
            <a:xfrm>
              <a:off x="4014557" y="3939546"/>
              <a:ext cx="7312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Sugar</a:t>
              </a:r>
              <a:r>
                <a:rPr lang="hu-HU" sz="1100"/>
                <a:t> </a:t>
              </a:r>
              <a:r>
                <a:rPr lang="hu-HU" sz="1100" err="1"/>
                <a:t>alc</a:t>
              </a:r>
              <a:r>
                <a:rPr lang="hu-HU" sz="1100"/>
                <a:t>.</a:t>
              </a:r>
            </a:p>
          </p:txBody>
        </p:sp>
        <p:sp>
          <p:nvSpPr>
            <p:cNvPr id="43" name="Szövegdoboz 42"/>
            <p:cNvSpPr txBox="1"/>
            <p:nvPr/>
          </p:nvSpPr>
          <p:spPr>
            <a:xfrm>
              <a:off x="4840043" y="3939546"/>
              <a:ext cx="9797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Organic</a:t>
              </a:r>
              <a:r>
                <a:rPr lang="hu-HU" sz="1100"/>
                <a:t> </a:t>
              </a:r>
              <a:r>
                <a:rPr lang="hu-HU" sz="1100" err="1"/>
                <a:t>acids</a:t>
              </a:r>
              <a:endParaRPr lang="hu-HU" sz="1100"/>
            </a:p>
          </p:txBody>
        </p:sp>
        <p:sp>
          <p:nvSpPr>
            <p:cNvPr id="44" name="Szövegdoboz 43"/>
            <p:cNvSpPr txBox="1"/>
            <p:nvPr/>
          </p:nvSpPr>
          <p:spPr>
            <a:xfrm>
              <a:off x="5975636" y="3930899"/>
              <a:ext cx="7120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err="1"/>
                <a:t>Inorg</a:t>
              </a:r>
              <a:r>
                <a:rPr lang="hu-HU" sz="1100"/>
                <a:t>. </a:t>
              </a:r>
              <a:r>
                <a:rPr lang="hu-HU" sz="1100" err="1"/>
                <a:t>ac</a:t>
              </a:r>
              <a:r>
                <a:rPr lang="hu-HU" sz="1100"/>
                <a:t>.</a:t>
              </a:r>
            </a:p>
          </p:txBody>
        </p:sp>
      </p:grpSp>
      <p:sp>
        <p:nvSpPr>
          <p:cNvPr id="49" name="Szövegdoboz 48"/>
          <p:cNvSpPr txBox="1"/>
          <p:nvPr/>
        </p:nvSpPr>
        <p:spPr>
          <a:xfrm>
            <a:off x="341006" y="8105208"/>
            <a:ext cx="62775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6 Fig. Metabolite composition of tubers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. T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e relative data shown on the y axis are derived from a comparison of the peak sizes of the samples and an internal standard, ribitol.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The m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eans were obtained from 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two consecutive experiments from four-five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biological repeats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(S2 Table). The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tandard deviations are indicated by error bars.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hu-HU" sz="1200" b="1" noProof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1" name="Diagram 50"/>
          <p:cNvGraphicFramePr>
            <a:graphicFrameLocks/>
          </p:cNvGraphicFramePr>
          <p:nvPr/>
        </p:nvGraphicFramePr>
        <p:xfrm>
          <a:off x="0" y="203200"/>
          <a:ext cx="6857999" cy="3468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0" name="Téglalap 49"/>
          <p:cNvSpPr/>
          <p:nvPr/>
        </p:nvSpPr>
        <p:spPr>
          <a:xfrm>
            <a:off x="138340" y="186870"/>
            <a:ext cx="6591300" cy="38195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53" name="Téglalap 52"/>
          <p:cNvSpPr/>
          <p:nvPr/>
        </p:nvSpPr>
        <p:spPr>
          <a:xfrm>
            <a:off x="163515" y="4127499"/>
            <a:ext cx="6591300" cy="38195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33292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2</TotalTime>
  <Words>95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Home</dc:creator>
  <cp:lastModifiedBy>sathiya vikram</cp:lastModifiedBy>
  <cp:revision>93</cp:revision>
  <dcterms:created xsi:type="dcterms:W3CDTF">2020-04-29T23:07:35Z</dcterms:created>
  <dcterms:modified xsi:type="dcterms:W3CDTF">2021-04-20T04:24:31Z</dcterms:modified>
</cp:coreProperties>
</file>